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79770EC-FFA2-4EB4-8935-79650386B945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4E5AD80-68EA-4A35-9F03-EE2486E037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82A3FC3-18FC-4208-B7C7-686EB305C0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EBAF0C0-4D48-4E8A-8D58-DFE6887A0877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C5E5469-3D77-4705-8C1C-0C6D0EFED4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1E789B2-851C-414E-B427-B37EF9B9E0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C322CED-F09B-4044-BB60-31BDD6BFE2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7CD275A-4486-44B7-8902-1254823957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5040"/>
            <a:ext cx="6170400" cy="7073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0F0817E-56D4-4486-9D46-AE193043AB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250D2D4-6A4D-408A-8EA4-07738B074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DCA7CDC-F2C9-4DCA-95B5-4848E18565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8A5F3D2-C04B-48B9-8820-1DA27EA6D0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4/4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EA1ADCA-8ABC-4114-9F2D-0235C999A159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21253" b="0"/>
          <a:stretch/>
        </p:blipFill>
        <p:spPr>
          <a:xfrm>
            <a:off x="476280" y="324000"/>
            <a:ext cx="5400720" cy="38671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21762" b="0"/>
          <a:stretch/>
        </p:blipFill>
        <p:spPr>
          <a:xfrm>
            <a:off x="476280" y="4211640"/>
            <a:ext cx="5365800" cy="38368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0" y="8028000"/>
            <a:ext cx="6858000" cy="82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APMAN heat maps of gene regulation and protein-related genes in glabrous cotyledons of (A) AtGL3+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. napus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(B) K-5-8 relative to Westar. Maps show numbers of changed ESTs and expression intensity. Blue blocks represent individual up-regulated genes. Red blocks represent individual down-regulated genes. Relative expression intensity scale is in log2 where ±5 represents ±log24 or greate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81000" y="5435640"/>
            <a:ext cx="1800360" cy="45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.  Glabrous cotyledons of ultra-hairy leaf K-5-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52640" y="1547640"/>
            <a:ext cx="1871640" cy="45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.  Glabrous cotyledons of hairy leaf AtGL3+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. napu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